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62" r:id="rId3"/>
    <p:sldId id="263" r:id="rId4"/>
    <p:sldId id="264" r:id="rId5"/>
    <p:sldId id="261" r:id="rId6"/>
    <p:sldId id="265" r:id="rId7"/>
    <p:sldId id="266" r:id="rId8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howGuides="1">
      <p:cViewPr>
        <p:scale>
          <a:sx n="100" d="100"/>
          <a:sy n="100" d="100"/>
        </p:scale>
        <p:origin x="-1374" y="-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BAACB3-0B1F-4A96-9F55-119A43E42461}" type="datetimeFigureOut">
              <a:rPr lang="en-GB" smtClean="0"/>
              <a:t>12/11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2C7425-973E-4688-BD07-04A4E7A94B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512254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BAACB3-0B1F-4A96-9F55-119A43E42461}" type="datetimeFigureOut">
              <a:rPr lang="en-GB" smtClean="0"/>
              <a:t>12/11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2C7425-973E-4688-BD07-04A4E7A94B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358237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BAACB3-0B1F-4A96-9F55-119A43E42461}" type="datetimeFigureOut">
              <a:rPr lang="en-GB" smtClean="0"/>
              <a:t>12/11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2C7425-973E-4688-BD07-04A4E7A94B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780512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BAACB3-0B1F-4A96-9F55-119A43E42461}" type="datetimeFigureOut">
              <a:rPr lang="en-GB" smtClean="0"/>
              <a:t>12/11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2C7425-973E-4688-BD07-04A4E7A94B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902504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BAACB3-0B1F-4A96-9F55-119A43E42461}" type="datetimeFigureOut">
              <a:rPr lang="en-GB" smtClean="0"/>
              <a:t>12/11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2C7425-973E-4688-BD07-04A4E7A94B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405660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BAACB3-0B1F-4A96-9F55-119A43E42461}" type="datetimeFigureOut">
              <a:rPr lang="en-GB" smtClean="0"/>
              <a:t>12/11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2C7425-973E-4688-BD07-04A4E7A94B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547392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BAACB3-0B1F-4A96-9F55-119A43E42461}" type="datetimeFigureOut">
              <a:rPr lang="en-GB" smtClean="0"/>
              <a:t>12/11/201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2C7425-973E-4688-BD07-04A4E7A94B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593139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BAACB3-0B1F-4A96-9F55-119A43E42461}" type="datetimeFigureOut">
              <a:rPr lang="en-GB" smtClean="0"/>
              <a:t>12/11/201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2C7425-973E-4688-BD07-04A4E7A94B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273632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BAACB3-0B1F-4A96-9F55-119A43E42461}" type="datetimeFigureOut">
              <a:rPr lang="en-GB" smtClean="0"/>
              <a:t>12/11/201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2C7425-973E-4688-BD07-04A4E7A94B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49163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BAACB3-0B1F-4A96-9F55-119A43E42461}" type="datetimeFigureOut">
              <a:rPr lang="en-GB" smtClean="0"/>
              <a:t>12/11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2C7425-973E-4688-BD07-04A4E7A94B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868042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BAACB3-0B1F-4A96-9F55-119A43E42461}" type="datetimeFigureOut">
              <a:rPr lang="en-GB" smtClean="0"/>
              <a:t>12/11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2C7425-973E-4688-BD07-04A4E7A94B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044917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BAACB3-0B1F-4A96-9F55-119A43E42461}" type="datetimeFigureOut">
              <a:rPr lang="en-GB" smtClean="0"/>
              <a:t>12/11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2C7425-973E-4688-BD07-04A4E7A94B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455005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png"/><Relationship Id="rId13" Type="http://schemas.openxmlformats.org/officeDocument/2006/relationships/image" Target="../media/image24.png"/><Relationship Id="rId3" Type="http://schemas.openxmlformats.org/officeDocument/2006/relationships/image" Target="../media/image14.png"/><Relationship Id="rId7" Type="http://schemas.openxmlformats.org/officeDocument/2006/relationships/image" Target="../media/image18.png"/><Relationship Id="rId12" Type="http://schemas.openxmlformats.org/officeDocument/2006/relationships/image" Target="../media/image23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7.png"/><Relationship Id="rId11" Type="http://schemas.openxmlformats.org/officeDocument/2006/relationships/image" Target="../media/image22.png"/><Relationship Id="rId5" Type="http://schemas.openxmlformats.org/officeDocument/2006/relationships/image" Target="../media/image16.png"/><Relationship Id="rId10" Type="http://schemas.openxmlformats.org/officeDocument/2006/relationships/image" Target="../media/image21.png"/><Relationship Id="rId4" Type="http://schemas.openxmlformats.org/officeDocument/2006/relationships/image" Target="../media/image15.png"/><Relationship Id="rId9" Type="http://schemas.openxmlformats.org/officeDocument/2006/relationships/image" Target="../media/image20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31.png"/><Relationship Id="rId13" Type="http://schemas.openxmlformats.org/officeDocument/2006/relationships/image" Target="../media/image36.png"/><Relationship Id="rId3" Type="http://schemas.openxmlformats.org/officeDocument/2006/relationships/image" Target="../media/image26.png"/><Relationship Id="rId7" Type="http://schemas.openxmlformats.org/officeDocument/2006/relationships/image" Target="../media/image30.png"/><Relationship Id="rId12" Type="http://schemas.openxmlformats.org/officeDocument/2006/relationships/image" Target="../media/image35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9.png"/><Relationship Id="rId11" Type="http://schemas.openxmlformats.org/officeDocument/2006/relationships/image" Target="../media/image34.png"/><Relationship Id="rId5" Type="http://schemas.openxmlformats.org/officeDocument/2006/relationships/image" Target="../media/image28.png"/><Relationship Id="rId10" Type="http://schemas.openxmlformats.org/officeDocument/2006/relationships/image" Target="../media/image33.png"/><Relationship Id="rId4" Type="http://schemas.openxmlformats.org/officeDocument/2006/relationships/image" Target="../media/image27.png"/><Relationship Id="rId9" Type="http://schemas.openxmlformats.org/officeDocument/2006/relationships/image" Target="../media/image32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43.png"/><Relationship Id="rId13" Type="http://schemas.openxmlformats.org/officeDocument/2006/relationships/image" Target="../media/image48.png"/><Relationship Id="rId3" Type="http://schemas.openxmlformats.org/officeDocument/2006/relationships/image" Target="../media/image38.png"/><Relationship Id="rId7" Type="http://schemas.openxmlformats.org/officeDocument/2006/relationships/image" Target="../media/image42.png"/><Relationship Id="rId12" Type="http://schemas.openxmlformats.org/officeDocument/2006/relationships/image" Target="../media/image47.png"/><Relationship Id="rId2" Type="http://schemas.openxmlformats.org/officeDocument/2006/relationships/image" Target="../media/image3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1.png"/><Relationship Id="rId11" Type="http://schemas.openxmlformats.org/officeDocument/2006/relationships/image" Target="../media/image46.png"/><Relationship Id="rId5" Type="http://schemas.openxmlformats.org/officeDocument/2006/relationships/image" Target="../media/image40.png"/><Relationship Id="rId10" Type="http://schemas.openxmlformats.org/officeDocument/2006/relationships/image" Target="../media/image45.png"/><Relationship Id="rId4" Type="http://schemas.openxmlformats.org/officeDocument/2006/relationships/image" Target="../media/image39.png"/><Relationship Id="rId9" Type="http://schemas.openxmlformats.org/officeDocument/2006/relationships/image" Target="../media/image44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55.png"/><Relationship Id="rId13" Type="http://schemas.openxmlformats.org/officeDocument/2006/relationships/image" Target="../media/image60.png"/><Relationship Id="rId3" Type="http://schemas.openxmlformats.org/officeDocument/2006/relationships/image" Target="../media/image50.png"/><Relationship Id="rId7" Type="http://schemas.openxmlformats.org/officeDocument/2006/relationships/image" Target="../media/image54.png"/><Relationship Id="rId12" Type="http://schemas.openxmlformats.org/officeDocument/2006/relationships/image" Target="../media/image59.png"/><Relationship Id="rId2" Type="http://schemas.openxmlformats.org/officeDocument/2006/relationships/image" Target="../media/image4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3.png"/><Relationship Id="rId11" Type="http://schemas.openxmlformats.org/officeDocument/2006/relationships/image" Target="../media/image58.png"/><Relationship Id="rId5" Type="http://schemas.openxmlformats.org/officeDocument/2006/relationships/image" Target="../media/image52.png"/><Relationship Id="rId10" Type="http://schemas.openxmlformats.org/officeDocument/2006/relationships/image" Target="../media/image57.png"/><Relationship Id="rId4" Type="http://schemas.openxmlformats.org/officeDocument/2006/relationships/image" Target="../media/image51.png"/><Relationship Id="rId9" Type="http://schemas.openxmlformats.org/officeDocument/2006/relationships/image" Target="../media/image56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67.png"/><Relationship Id="rId13" Type="http://schemas.openxmlformats.org/officeDocument/2006/relationships/image" Target="../media/image72.png"/><Relationship Id="rId3" Type="http://schemas.openxmlformats.org/officeDocument/2006/relationships/image" Target="../media/image62.png"/><Relationship Id="rId7" Type="http://schemas.openxmlformats.org/officeDocument/2006/relationships/image" Target="../media/image66.png"/><Relationship Id="rId12" Type="http://schemas.openxmlformats.org/officeDocument/2006/relationships/image" Target="../media/image71.png"/><Relationship Id="rId2" Type="http://schemas.openxmlformats.org/officeDocument/2006/relationships/image" Target="../media/image6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5.png"/><Relationship Id="rId11" Type="http://schemas.openxmlformats.org/officeDocument/2006/relationships/image" Target="../media/image70.png"/><Relationship Id="rId5" Type="http://schemas.openxmlformats.org/officeDocument/2006/relationships/image" Target="../media/image64.png"/><Relationship Id="rId10" Type="http://schemas.openxmlformats.org/officeDocument/2006/relationships/image" Target="../media/image69.png"/><Relationship Id="rId4" Type="http://schemas.openxmlformats.org/officeDocument/2006/relationships/image" Target="../media/image63.png"/><Relationship Id="rId9" Type="http://schemas.openxmlformats.org/officeDocument/2006/relationships/image" Target="../media/image68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79.png"/><Relationship Id="rId3" Type="http://schemas.openxmlformats.org/officeDocument/2006/relationships/image" Target="../media/image74.png"/><Relationship Id="rId7" Type="http://schemas.openxmlformats.org/officeDocument/2006/relationships/image" Target="../media/image78.png"/><Relationship Id="rId2" Type="http://schemas.openxmlformats.org/officeDocument/2006/relationships/image" Target="../media/image7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7.png"/><Relationship Id="rId5" Type="http://schemas.openxmlformats.org/officeDocument/2006/relationships/image" Target="../media/image76.png"/><Relationship Id="rId10" Type="http://schemas.openxmlformats.org/officeDocument/2006/relationships/image" Target="../media/image81.png"/><Relationship Id="rId4" Type="http://schemas.openxmlformats.org/officeDocument/2006/relationships/image" Target="../media/image75.png"/><Relationship Id="rId9" Type="http://schemas.openxmlformats.org/officeDocument/2006/relationships/image" Target="../media/image8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" name="Straight Connector 4"/>
          <p:cNvCxnSpPr/>
          <p:nvPr/>
        </p:nvCxnSpPr>
        <p:spPr>
          <a:xfrm>
            <a:off x="219398" y="6364838"/>
            <a:ext cx="6801962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Connector 5"/>
          <p:cNvCxnSpPr/>
          <p:nvPr/>
        </p:nvCxnSpPr>
        <p:spPr>
          <a:xfrm>
            <a:off x="191379" y="7949014"/>
            <a:ext cx="6801962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42433" y="1691679"/>
            <a:ext cx="2344573" cy="1579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22681" y="1843088"/>
            <a:ext cx="2023899" cy="136341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2141" y="1691678"/>
            <a:ext cx="2344574" cy="157944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2" name="Picture 8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0637" y="3271123"/>
            <a:ext cx="2344574" cy="157944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3" name="Picture 9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15211" y="3271123"/>
            <a:ext cx="2199018" cy="150954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4" name="Picture 10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14229" y="3271123"/>
            <a:ext cx="2240805" cy="150954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5" name="Picture 11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46666" y="4780663"/>
            <a:ext cx="2263892" cy="158417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6" name="Picture 12"/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82774" y="4853814"/>
            <a:ext cx="2263892" cy="158417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7" name="Picture 13"/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029" y="4780663"/>
            <a:ext cx="2307744" cy="158417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8" name="Picture 14"/>
          <p:cNvPicPr>
            <a:picLocks noChangeAspect="1"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134" y="6364839"/>
            <a:ext cx="2331639" cy="16315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9" name="Picture 15"/>
          <p:cNvPicPr>
            <a:picLocks noChangeAspect="1" noChangeArrowheads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82774" y="6364839"/>
            <a:ext cx="2263892" cy="16315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40" name="Picture 16"/>
          <p:cNvPicPr>
            <a:picLocks noChangeAspect="1" noChangeArrowheads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46666" y="6364838"/>
            <a:ext cx="2309057" cy="16315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5666460" y="974323"/>
            <a:ext cx="21602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A</a:t>
            </a:r>
            <a:r>
              <a:rPr lang="en-GB" dirty="0" smtClean="0"/>
              <a:t>D</a:t>
            </a:r>
            <a:endParaRPr lang="en-GB" dirty="0"/>
          </a:p>
        </p:txBody>
      </p:sp>
      <p:sp>
        <p:nvSpPr>
          <p:cNvPr id="93" name="TextBox 92"/>
          <p:cNvSpPr txBox="1"/>
          <p:nvPr/>
        </p:nvSpPr>
        <p:spPr>
          <a:xfrm>
            <a:off x="404664" y="974323"/>
            <a:ext cx="21602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Control</a:t>
            </a:r>
            <a:endParaRPr lang="en-GB" dirty="0"/>
          </a:p>
        </p:txBody>
      </p:sp>
      <p:sp>
        <p:nvSpPr>
          <p:cNvPr id="94" name="TextBox 93"/>
          <p:cNvSpPr txBox="1"/>
          <p:nvPr/>
        </p:nvSpPr>
        <p:spPr>
          <a:xfrm>
            <a:off x="3284984" y="1002335"/>
            <a:ext cx="21602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LBD</a:t>
            </a:r>
            <a:endParaRPr lang="en-GB" dirty="0"/>
          </a:p>
        </p:txBody>
      </p:sp>
      <p:sp>
        <p:nvSpPr>
          <p:cNvPr id="95" name="Rectangle 94"/>
          <p:cNvSpPr/>
          <p:nvPr/>
        </p:nvSpPr>
        <p:spPr>
          <a:xfrm>
            <a:off x="58700" y="6351636"/>
            <a:ext cx="2316506" cy="1644785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6" name="Rectangle 95"/>
          <p:cNvSpPr/>
          <p:nvPr/>
        </p:nvSpPr>
        <p:spPr>
          <a:xfrm>
            <a:off x="48860" y="1550241"/>
            <a:ext cx="2316506" cy="1644785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7" name="Rectangle 96"/>
          <p:cNvSpPr/>
          <p:nvPr/>
        </p:nvSpPr>
        <p:spPr>
          <a:xfrm>
            <a:off x="2409977" y="6358236"/>
            <a:ext cx="2316506" cy="1644785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8" name="Rectangle 97"/>
          <p:cNvSpPr/>
          <p:nvPr/>
        </p:nvSpPr>
        <p:spPr>
          <a:xfrm>
            <a:off x="4739625" y="6334534"/>
            <a:ext cx="2115409" cy="1644785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9" name="TextBox 11"/>
          <p:cNvSpPr txBox="1"/>
          <p:nvPr/>
        </p:nvSpPr>
        <p:spPr>
          <a:xfrm>
            <a:off x="229781" y="28883"/>
            <a:ext cx="659202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Individual correlation graphs for total tau in each condition. R</a:t>
            </a:r>
            <a:r>
              <a:rPr lang="en-GB" sz="1400" baseline="30000" dirty="0" smtClean="0"/>
              <a:t>2</a:t>
            </a:r>
            <a:r>
              <a:rPr lang="en-GB" sz="1400" dirty="0" smtClean="0"/>
              <a:t> and p values are given in supplementary table 3. Red boxed graphs have p&lt;0.01 yellow squared p value 0.05-0.01</a:t>
            </a:r>
            <a:endParaRPr lang="en-GB" sz="1400" dirty="0"/>
          </a:p>
        </p:txBody>
      </p:sp>
    </p:spTree>
    <p:extLst>
      <p:ext uri="{BB962C8B-B14F-4D97-AF65-F5344CB8AC3E}">
        <p14:creationId xmlns:p14="http://schemas.microsoft.com/office/powerpoint/2010/main" val="294042893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4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35321" y="1024510"/>
            <a:ext cx="2201950" cy="158694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47733" y="918466"/>
            <a:ext cx="2502316" cy="175101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" name="Picture 26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021" y="1053432"/>
            <a:ext cx="2267844" cy="15869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27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28191" y="2630551"/>
            <a:ext cx="2335708" cy="16344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" name="Picture 29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1410" y="2630551"/>
            <a:ext cx="2267841" cy="163442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1" name="Picture 40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1411" y="5896166"/>
            <a:ext cx="2267844" cy="16024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2" name="Picture 41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563" y="5896165"/>
            <a:ext cx="2268954" cy="160324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3" name="Picture 42"/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22" y="4264983"/>
            <a:ext cx="2299243" cy="16311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4" name="TextBox 13"/>
          <p:cNvSpPr txBox="1"/>
          <p:nvPr/>
        </p:nvSpPr>
        <p:spPr>
          <a:xfrm>
            <a:off x="5801194" y="682660"/>
            <a:ext cx="21602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A</a:t>
            </a:r>
            <a:r>
              <a:rPr lang="en-GB" dirty="0" smtClean="0"/>
              <a:t>D</a:t>
            </a:r>
            <a:endParaRPr lang="en-GB" dirty="0"/>
          </a:p>
        </p:txBody>
      </p:sp>
      <p:sp>
        <p:nvSpPr>
          <p:cNvPr id="15" name="TextBox 14"/>
          <p:cNvSpPr txBox="1"/>
          <p:nvPr/>
        </p:nvSpPr>
        <p:spPr>
          <a:xfrm>
            <a:off x="548680" y="682660"/>
            <a:ext cx="21602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Control</a:t>
            </a:r>
            <a:endParaRPr lang="en-GB" dirty="0"/>
          </a:p>
        </p:txBody>
      </p:sp>
      <p:sp>
        <p:nvSpPr>
          <p:cNvPr id="16" name="TextBox 15"/>
          <p:cNvSpPr txBox="1"/>
          <p:nvPr/>
        </p:nvSpPr>
        <p:spPr>
          <a:xfrm>
            <a:off x="3221360" y="682660"/>
            <a:ext cx="21602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LBD</a:t>
            </a:r>
            <a:endParaRPr lang="en-GB" dirty="0"/>
          </a:p>
        </p:txBody>
      </p:sp>
      <p:sp>
        <p:nvSpPr>
          <p:cNvPr id="17" name="Rectangle 16"/>
          <p:cNvSpPr/>
          <p:nvPr/>
        </p:nvSpPr>
        <p:spPr>
          <a:xfrm>
            <a:off x="2318815" y="995589"/>
            <a:ext cx="2307508" cy="1644785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55868" y="2657295"/>
            <a:ext cx="2219493" cy="159958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8" name="Rectangle 17"/>
          <p:cNvSpPr/>
          <p:nvPr/>
        </p:nvSpPr>
        <p:spPr>
          <a:xfrm>
            <a:off x="2318815" y="2668610"/>
            <a:ext cx="2316506" cy="1514234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38458" y="4218943"/>
            <a:ext cx="2327218" cy="16772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0" name="Rectangle 19"/>
          <p:cNvSpPr/>
          <p:nvPr/>
        </p:nvSpPr>
        <p:spPr>
          <a:xfrm>
            <a:off x="2340638" y="4169241"/>
            <a:ext cx="2259146" cy="1644785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8" name="Picture 30"/>
          <p:cNvPicPr>
            <a:picLocks noChangeAspect="1" noChangeArrowheads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08291" y="4182844"/>
            <a:ext cx="2273023" cy="163816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64624" y="5814026"/>
            <a:ext cx="2430122" cy="17171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125916653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38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86853" y="1907704"/>
            <a:ext cx="2267846" cy="158694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" name="Picture 39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114" y="1907704"/>
            <a:ext cx="2267846" cy="158694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43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02" y="3494647"/>
            <a:ext cx="2320458" cy="16237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Picture 44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19008" y="3481127"/>
            <a:ext cx="2271796" cy="163727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" name="Picture 45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86853" y="3494647"/>
            <a:ext cx="2253036" cy="16237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" name="Picture 47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90804" y="5118407"/>
            <a:ext cx="2263893" cy="159967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" name="Picture 50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3349" y="5118406"/>
            <a:ext cx="2219611" cy="159967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1" name="Picture 51"/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117" y="6718078"/>
            <a:ext cx="2267842" cy="158694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3" name="Picture 53"/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86853" y="6718079"/>
            <a:ext cx="2201948" cy="158694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4" name="TextBox 13"/>
          <p:cNvSpPr txBox="1"/>
          <p:nvPr/>
        </p:nvSpPr>
        <p:spPr>
          <a:xfrm>
            <a:off x="5801194" y="682660"/>
            <a:ext cx="21602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A</a:t>
            </a:r>
            <a:r>
              <a:rPr lang="en-GB" dirty="0" smtClean="0"/>
              <a:t>D</a:t>
            </a:r>
            <a:endParaRPr lang="en-GB" dirty="0"/>
          </a:p>
        </p:txBody>
      </p:sp>
      <p:sp>
        <p:nvSpPr>
          <p:cNvPr id="15" name="TextBox 14"/>
          <p:cNvSpPr txBox="1"/>
          <p:nvPr/>
        </p:nvSpPr>
        <p:spPr>
          <a:xfrm>
            <a:off x="548680" y="682660"/>
            <a:ext cx="21602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Control</a:t>
            </a:r>
            <a:endParaRPr lang="en-GB" dirty="0"/>
          </a:p>
        </p:txBody>
      </p:sp>
      <p:sp>
        <p:nvSpPr>
          <p:cNvPr id="16" name="TextBox 15"/>
          <p:cNvSpPr txBox="1"/>
          <p:nvPr/>
        </p:nvSpPr>
        <p:spPr>
          <a:xfrm>
            <a:off x="3221360" y="682660"/>
            <a:ext cx="21602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LBD</a:t>
            </a:r>
            <a:endParaRPr lang="en-GB" dirty="0"/>
          </a:p>
        </p:txBody>
      </p:sp>
      <p:sp>
        <p:nvSpPr>
          <p:cNvPr id="17" name="Rectangle 16"/>
          <p:cNvSpPr/>
          <p:nvPr/>
        </p:nvSpPr>
        <p:spPr>
          <a:xfrm>
            <a:off x="2502" y="6660232"/>
            <a:ext cx="2316506" cy="164478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6146" name="Picture 2"/>
          <p:cNvPicPr>
            <a:picLocks noChangeAspect="1"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65643" y="1816733"/>
            <a:ext cx="2378528" cy="166439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147" name="Picture 3"/>
          <p:cNvPicPr>
            <a:picLocks noChangeAspect="1" noChangeArrowheads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26910" y="5044156"/>
            <a:ext cx="2355492" cy="166439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9" name="Rectangle 18"/>
          <p:cNvSpPr/>
          <p:nvPr/>
        </p:nvSpPr>
        <p:spPr>
          <a:xfrm>
            <a:off x="10404" y="5118401"/>
            <a:ext cx="2316506" cy="1512908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6148" name="Picture 4"/>
          <p:cNvPicPr>
            <a:picLocks noChangeAspect="1" noChangeArrowheads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74414" y="6716738"/>
            <a:ext cx="2269758" cy="158828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244014848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50344" y="1700050"/>
            <a:ext cx="2451919" cy="17325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" name="Picture 54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60240" y="1763688"/>
            <a:ext cx="2271797" cy="16052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" name="Picture 56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1619" y="1763688"/>
            <a:ext cx="2294015" cy="16052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58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549" y="3368946"/>
            <a:ext cx="2267847" cy="15567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Picture 59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88444" y="3368945"/>
            <a:ext cx="2267846" cy="15567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" name="Picture 60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56288" y="3368947"/>
            <a:ext cx="2267847" cy="15567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" name="Picture 61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56289" y="4925737"/>
            <a:ext cx="2267844" cy="15869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" name="Picture 63"/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547" y="4925733"/>
            <a:ext cx="2267849" cy="158694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1" name="Picture 64"/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500" y="6512678"/>
            <a:ext cx="2263896" cy="158417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4" name="TextBox 13"/>
          <p:cNvSpPr txBox="1"/>
          <p:nvPr/>
        </p:nvSpPr>
        <p:spPr>
          <a:xfrm>
            <a:off x="5801194" y="682660"/>
            <a:ext cx="21602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A</a:t>
            </a:r>
            <a:r>
              <a:rPr lang="en-GB" dirty="0" smtClean="0"/>
              <a:t>D</a:t>
            </a:r>
            <a:endParaRPr lang="en-GB" dirty="0"/>
          </a:p>
        </p:txBody>
      </p:sp>
      <p:sp>
        <p:nvSpPr>
          <p:cNvPr id="15" name="TextBox 14"/>
          <p:cNvSpPr txBox="1"/>
          <p:nvPr/>
        </p:nvSpPr>
        <p:spPr>
          <a:xfrm>
            <a:off x="548680" y="682660"/>
            <a:ext cx="21602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Control</a:t>
            </a:r>
            <a:endParaRPr lang="en-GB" dirty="0"/>
          </a:p>
        </p:txBody>
      </p:sp>
      <p:sp>
        <p:nvSpPr>
          <p:cNvPr id="16" name="TextBox 15"/>
          <p:cNvSpPr txBox="1"/>
          <p:nvPr/>
        </p:nvSpPr>
        <p:spPr>
          <a:xfrm>
            <a:off x="3221360" y="682660"/>
            <a:ext cx="21602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LBD</a:t>
            </a:r>
            <a:endParaRPr lang="en-GB" dirty="0"/>
          </a:p>
        </p:txBody>
      </p:sp>
      <p:sp>
        <p:nvSpPr>
          <p:cNvPr id="18" name="Rectangle 17"/>
          <p:cNvSpPr/>
          <p:nvPr/>
        </p:nvSpPr>
        <p:spPr>
          <a:xfrm>
            <a:off x="4582459" y="1649135"/>
            <a:ext cx="2158909" cy="1644785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45003" y="4880599"/>
            <a:ext cx="2357259" cy="16495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7" name="Rectangle 16"/>
          <p:cNvSpPr/>
          <p:nvPr/>
        </p:nvSpPr>
        <p:spPr>
          <a:xfrm>
            <a:off x="28498" y="6452072"/>
            <a:ext cx="2316506" cy="164478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2052" name="Picture 4"/>
          <p:cNvPicPr>
            <a:picLocks noChangeAspect="1" noChangeArrowheads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39530" y="6484437"/>
            <a:ext cx="2304256" cy="16124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3" name="Picture 66"/>
          <p:cNvPicPr>
            <a:picLocks noChangeAspect="1" noChangeArrowheads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60240" y="6512680"/>
            <a:ext cx="2263895" cy="15841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181957800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7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49038" y="971600"/>
            <a:ext cx="2271406" cy="158943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" name="Picture 18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85146" y="971599"/>
            <a:ext cx="2263892" cy="158417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" name="Picture 19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759" y="971600"/>
            <a:ext cx="2257387" cy="157962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20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398" y="2551224"/>
            <a:ext cx="2271796" cy="1559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" name="Picture 69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34989" y="4293861"/>
            <a:ext cx="2434209" cy="167098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4" name="TextBox 13"/>
          <p:cNvSpPr txBox="1"/>
          <p:nvPr/>
        </p:nvSpPr>
        <p:spPr>
          <a:xfrm>
            <a:off x="5801194" y="682660"/>
            <a:ext cx="21602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A</a:t>
            </a:r>
            <a:r>
              <a:rPr lang="en-GB" dirty="0" smtClean="0"/>
              <a:t>D</a:t>
            </a:r>
            <a:endParaRPr lang="en-GB" dirty="0"/>
          </a:p>
        </p:txBody>
      </p:sp>
      <p:sp>
        <p:nvSpPr>
          <p:cNvPr id="15" name="TextBox 14"/>
          <p:cNvSpPr txBox="1"/>
          <p:nvPr/>
        </p:nvSpPr>
        <p:spPr>
          <a:xfrm>
            <a:off x="548680" y="682660"/>
            <a:ext cx="21602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Control</a:t>
            </a:r>
            <a:endParaRPr lang="en-GB" dirty="0"/>
          </a:p>
        </p:txBody>
      </p:sp>
      <p:sp>
        <p:nvSpPr>
          <p:cNvPr id="16" name="TextBox 15"/>
          <p:cNvSpPr txBox="1"/>
          <p:nvPr/>
        </p:nvSpPr>
        <p:spPr>
          <a:xfrm>
            <a:off x="3221360" y="682660"/>
            <a:ext cx="21602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LBD</a:t>
            </a:r>
            <a:endParaRPr lang="en-GB" dirty="0"/>
          </a:p>
        </p:txBody>
      </p:sp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59453" y="4226533"/>
            <a:ext cx="2556322" cy="175481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" name="Picture 67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49038" y="4252888"/>
            <a:ext cx="2434209" cy="167098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77" name="Picture 5"/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31947" y="2433228"/>
            <a:ext cx="2588544" cy="177693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" name="Picture 23"/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7955" y="2561034"/>
            <a:ext cx="2323327" cy="16257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7" name="Rectangle 16"/>
          <p:cNvSpPr/>
          <p:nvPr/>
        </p:nvSpPr>
        <p:spPr>
          <a:xfrm>
            <a:off x="27759" y="1007074"/>
            <a:ext cx="2321533" cy="154870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3078" name="Picture 6"/>
          <p:cNvPicPr>
            <a:picLocks noChangeAspect="1"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08958" y="6031694"/>
            <a:ext cx="2440084" cy="170746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79" name="Picture 7"/>
          <p:cNvPicPr>
            <a:picLocks noChangeAspect="1" noChangeArrowheads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68405" y="6016744"/>
            <a:ext cx="2425611" cy="169734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80" name="Picture 8"/>
          <p:cNvPicPr>
            <a:picLocks noChangeAspect="1" noChangeArrowheads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4802" y="6129344"/>
            <a:ext cx="2160987" cy="151216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8" name="Rectangle 17"/>
          <p:cNvSpPr/>
          <p:nvPr/>
        </p:nvSpPr>
        <p:spPr>
          <a:xfrm>
            <a:off x="4577955" y="5913230"/>
            <a:ext cx="2316506" cy="1644785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0428721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67146" y="1105398"/>
            <a:ext cx="2358351" cy="166641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76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2880871"/>
            <a:ext cx="2147610" cy="151750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Picture 77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04864" y="2985411"/>
            <a:ext cx="1951405" cy="13788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" name="Picture 78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54775" y="3019510"/>
            <a:ext cx="1989574" cy="13788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" name="Picture 79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90529" y="4716016"/>
            <a:ext cx="1951405" cy="13788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" name="Picture 80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43033" y="4716016"/>
            <a:ext cx="1913236" cy="13788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" name="Picture 81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571" y="4716016"/>
            <a:ext cx="1913236" cy="13788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1" name="Picture 82"/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26080" y="6660232"/>
            <a:ext cx="2008659" cy="13788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2" name="Picture 83"/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47610" y="6634948"/>
            <a:ext cx="2008659" cy="13788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3" name="Picture 84"/>
          <p:cNvPicPr>
            <a:picLocks noChangeAspect="1"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33275" y="6634948"/>
            <a:ext cx="2008659" cy="13788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4" name="TextBox 13"/>
          <p:cNvSpPr txBox="1"/>
          <p:nvPr/>
        </p:nvSpPr>
        <p:spPr>
          <a:xfrm>
            <a:off x="5801194" y="682660"/>
            <a:ext cx="21602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A</a:t>
            </a:r>
            <a:r>
              <a:rPr lang="en-GB" dirty="0" smtClean="0"/>
              <a:t>D</a:t>
            </a:r>
            <a:endParaRPr lang="en-GB" dirty="0"/>
          </a:p>
        </p:txBody>
      </p:sp>
      <p:sp>
        <p:nvSpPr>
          <p:cNvPr id="15" name="TextBox 14"/>
          <p:cNvSpPr txBox="1"/>
          <p:nvPr/>
        </p:nvSpPr>
        <p:spPr>
          <a:xfrm>
            <a:off x="548680" y="682660"/>
            <a:ext cx="21602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Control</a:t>
            </a:r>
            <a:endParaRPr lang="en-GB" dirty="0"/>
          </a:p>
        </p:txBody>
      </p:sp>
      <p:sp>
        <p:nvSpPr>
          <p:cNvPr id="16" name="TextBox 15"/>
          <p:cNvSpPr txBox="1"/>
          <p:nvPr/>
        </p:nvSpPr>
        <p:spPr>
          <a:xfrm>
            <a:off x="3221360" y="682660"/>
            <a:ext cx="21602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LBD</a:t>
            </a:r>
            <a:endParaRPr lang="en-GB" dirty="0"/>
          </a:p>
        </p:txBody>
      </p:sp>
      <p:sp>
        <p:nvSpPr>
          <p:cNvPr id="17" name="Rectangle 16"/>
          <p:cNvSpPr/>
          <p:nvPr/>
        </p:nvSpPr>
        <p:spPr>
          <a:xfrm>
            <a:off x="0" y="2926046"/>
            <a:ext cx="2147610" cy="1519937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4099" name="Picture 3"/>
          <p:cNvPicPr>
            <a:picLocks noChangeAspect="1" noChangeArrowheads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64219" y="1290065"/>
            <a:ext cx="2097006" cy="148174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00" name="Picture 4"/>
          <p:cNvPicPr>
            <a:picLocks noChangeAspect="1" noChangeArrowheads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26080" y="1182521"/>
            <a:ext cx="2140058" cy="151216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18439997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85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61989" y="1329725"/>
            <a:ext cx="2226806" cy="1558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" name="Picture 86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26806" y="1259632"/>
            <a:ext cx="2226806" cy="156361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" name="Picture 87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1259632"/>
            <a:ext cx="2226806" cy="162831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88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3463766"/>
            <a:ext cx="2226806" cy="1558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" name="Picture 90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31194" y="3334364"/>
            <a:ext cx="2226806" cy="1558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" name="Picture 91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27473" y="5522323"/>
            <a:ext cx="2226806" cy="1558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" name="Picture 93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5468405"/>
            <a:ext cx="2269940" cy="161214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1" name="TextBox 10"/>
          <p:cNvSpPr txBox="1"/>
          <p:nvPr/>
        </p:nvSpPr>
        <p:spPr>
          <a:xfrm>
            <a:off x="5801194" y="682660"/>
            <a:ext cx="21602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A</a:t>
            </a:r>
            <a:r>
              <a:rPr lang="en-GB" dirty="0" smtClean="0"/>
              <a:t>D</a:t>
            </a:r>
            <a:endParaRPr lang="en-GB" dirty="0"/>
          </a:p>
        </p:txBody>
      </p:sp>
      <p:sp>
        <p:nvSpPr>
          <p:cNvPr id="12" name="TextBox 11"/>
          <p:cNvSpPr txBox="1"/>
          <p:nvPr/>
        </p:nvSpPr>
        <p:spPr>
          <a:xfrm>
            <a:off x="548680" y="682660"/>
            <a:ext cx="21602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Control</a:t>
            </a:r>
            <a:endParaRPr lang="en-GB" dirty="0"/>
          </a:p>
        </p:txBody>
      </p:sp>
      <p:sp>
        <p:nvSpPr>
          <p:cNvPr id="13" name="TextBox 12"/>
          <p:cNvSpPr txBox="1"/>
          <p:nvPr/>
        </p:nvSpPr>
        <p:spPr>
          <a:xfrm>
            <a:off x="3053519" y="654459"/>
            <a:ext cx="21602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LBD</a:t>
            </a:r>
            <a:endParaRPr lang="en-GB" dirty="0"/>
          </a:p>
        </p:txBody>
      </p:sp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35219" y="3329701"/>
            <a:ext cx="2609979" cy="182635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4" name="Rectangle 13"/>
          <p:cNvSpPr/>
          <p:nvPr/>
        </p:nvSpPr>
        <p:spPr>
          <a:xfrm>
            <a:off x="4399253" y="3237366"/>
            <a:ext cx="2316506" cy="1644785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5123" name="Picture 3"/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33823" y="5503454"/>
            <a:ext cx="2297428" cy="157709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5" name="Rectangle 14"/>
          <p:cNvSpPr/>
          <p:nvPr/>
        </p:nvSpPr>
        <p:spPr>
          <a:xfrm>
            <a:off x="4370377" y="5384006"/>
            <a:ext cx="2316506" cy="164478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708879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264</TotalTime>
  <Words>52</Words>
  <Application>Microsoft Office PowerPoint</Application>
  <PresentationFormat>On-screen Show (4:3)</PresentationFormat>
  <Paragraphs>22</Paragraphs>
  <Slides>7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8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CL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endy Heywood</dc:creator>
  <cp:lastModifiedBy>Wendy Heywood</cp:lastModifiedBy>
  <cp:revision>44</cp:revision>
  <dcterms:created xsi:type="dcterms:W3CDTF">2015-11-03T13:39:46Z</dcterms:created>
  <dcterms:modified xsi:type="dcterms:W3CDTF">2015-11-12T11:32:18Z</dcterms:modified>
</cp:coreProperties>
</file>